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5"/>
  </p:notesMasterIdLst>
  <p:sldIdLst>
    <p:sldId id="1115" r:id="rId2"/>
    <p:sldId id="1073" r:id="rId3"/>
    <p:sldId id="1095" r:id="rId4"/>
    <p:sldId id="1108" r:id="rId5"/>
    <p:sldId id="1104" r:id="rId6"/>
    <p:sldId id="1109" r:id="rId7"/>
    <p:sldId id="1110" r:id="rId8"/>
    <p:sldId id="1111" r:id="rId9"/>
    <p:sldId id="1112" r:id="rId10"/>
    <p:sldId id="1113" r:id="rId11"/>
    <p:sldId id="1114" r:id="rId12"/>
    <p:sldId id="1058" r:id="rId13"/>
    <p:sldId id="1078" r:id="rId14"/>
  </p:sldIdLst>
  <p:sldSz cx="18288000" cy="10287000"/>
  <p:notesSz cx="6858000" cy="9144000"/>
  <p:embeddedFontLst>
    <p:embeddedFont>
      <p:font typeface="Assistant" pitchFamily="2" charset="-79"/>
      <p:regular r:id="rId16"/>
      <p:bold r:id="rId17"/>
    </p:embeddedFont>
    <p:embeddedFont>
      <p:font typeface="Assistant Bold" charset="-79"/>
      <p:regular r:id="rId18"/>
      <p:bold r:id="rId19"/>
    </p:embeddedFont>
    <p:embeddedFont>
      <p:font typeface="Assistant ExtraBold" pitchFamily="2" charset="-79"/>
      <p:bold r:id="rId20"/>
    </p:embeddedFont>
    <p:embeddedFont>
      <p:font typeface="Assistant Regular" charset="-79"/>
      <p:regular r:id="rId21"/>
    </p:embeddedFont>
    <p:embeddedFont>
      <p:font typeface="Assistant SemiBold" pitchFamily="2" charset="-79"/>
      <p:bold r:id="rId22"/>
    </p:embeddedFont>
    <p:embeddedFont>
      <p:font typeface="Calibri" panose="020F0502020204030204" pitchFamily="34" charset="0"/>
      <p:regular r:id="rId23"/>
      <p:bold r:id="rId24"/>
      <p:italic r:id="rId25"/>
      <p:boldItalic r:id="rId26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3.fntdata"/><Relationship Id="rId26" Type="http://schemas.openxmlformats.org/officeDocument/2006/relationships/font" Target="fonts/font11.fntdata"/><Relationship Id="rId3" Type="http://schemas.openxmlformats.org/officeDocument/2006/relationships/slide" Target="slides/slide2.xml"/><Relationship Id="rId21" Type="http://schemas.openxmlformats.org/officeDocument/2006/relationships/font" Target="fonts/font6.fntdata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font" Target="fonts/font2.fntdata"/><Relationship Id="rId25" Type="http://schemas.openxmlformats.org/officeDocument/2006/relationships/font" Target="fonts/font10.fntdata"/><Relationship Id="rId2" Type="http://schemas.openxmlformats.org/officeDocument/2006/relationships/slide" Target="slides/slide1.xml"/><Relationship Id="rId16" Type="http://schemas.openxmlformats.org/officeDocument/2006/relationships/font" Target="fonts/font1.fntdata"/><Relationship Id="rId20" Type="http://schemas.openxmlformats.org/officeDocument/2006/relationships/font" Target="fonts/font5.fntdata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9.fntdata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23" Type="http://schemas.openxmlformats.org/officeDocument/2006/relationships/font" Target="fonts/font8.fntdata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font" Target="fonts/font4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7.fntdata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1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907216838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4804426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67602360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97512920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90068316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dirty="0" err="1"/>
              <a:t>otuurhfe</a:t>
            </a:r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32759483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43778770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89611565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6249207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biz.libretexts.org/Courses/Prince_Georges_Community_College/BMT_1550:_Supervision_(Perry_2021)/04:_Identify_the_major_decision_making_techniques_and_their_formats./4.02:_Problem_Solving_and_Decision_Making_in_Groups" TargetMode="Externa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www.pexels.com/photo/a-change-in-lifestyle-apple-banana-centimeter-161704/" TargetMode="Externa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pxhere.com/en/photo/1347523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sv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rebelem.com/getting-things-done-hyperdistracted-world/work-smarter-not-harder-3d-rendering-blue-street-sign/" TargetMode="Externa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www.cutedrop.com.br/2018/08/5-dicas-para-deixar-seu-ambiente-de-trabalho-mais-estimulante-para-a-criatividade/" TargetMode="Externa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www.publicdomainpictures.net/view-image.php?image=65970&amp;picture=schoolboy-is-sitting-on-books" TargetMode="Externa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svg"/><Relationship Id="rId4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sketchfab.com/3d-models/concrete-barrier-c25d5825dc544c77866ce4853554fc93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1134219"/>
            <a:chOff x="1573698" y="-152998"/>
            <a:chExt cx="7219847" cy="1512292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6999" y="-12404"/>
              <a:ext cx="7106546" cy="1231107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Session #19</a:t>
              </a: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Keep Moving!</a:t>
              </a:r>
              <a:endParaRPr lang="en-US" sz="3000" spc="874" dirty="0">
                <a:solidFill>
                  <a:schemeClr val="tx1">
                    <a:lumMod val="65000"/>
                    <a:lumOff val="35000"/>
                  </a:schemeClr>
                </a:solidFill>
                <a:latin typeface="Assistant SemiBold" panose="020B0604020202020204" pitchFamily="2" charset="-79"/>
                <a:cs typeface="Assistant SemiBold" panose="020B0604020202020204" pitchFamily="2" charset="-79"/>
              </a:endParaRP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Un-Healthy Choice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rcRect l="10781" r="10781"/>
          <a:stretch/>
        </p:blipFill>
        <p:spPr bwMode="auto">
          <a:xfrm>
            <a:off x="12190803" y="2682989"/>
            <a:ext cx="5743139" cy="5719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492085" y="2044309"/>
            <a:ext cx="10698718" cy="82176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US" sz="44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What are some ways you choose unhealthy things that get in the way of our goals?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Sitting for long periods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Eating more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Buying unhealthy snacks and beverages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Watching TV for long periods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Not weighing everyday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Not logging food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Other- discuss?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82898295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ealthy Choice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rcRect l="16434" r="16434"/>
          <a:stretch/>
        </p:blipFill>
        <p:spPr bwMode="auto">
          <a:xfrm>
            <a:off x="12190803" y="2682989"/>
            <a:ext cx="5743139" cy="5719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492085" y="2044309"/>
            <a:ext cx="10698718" cy="82176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US" sz="44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When barriers strike how do we overcome them?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Break up walks into 10 minute chunks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Get activity early in the day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Jog in place watching TV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Go to a shopping mall to walk on a rainy/cold day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Watch an exercise video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Take an exercise class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Other- discuss?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127537221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878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Let’s Keep Moving!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those meals and take your health EVERYDAY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onitor your progress and identify areas for improvement towards YOUR GO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im to get in 130 min of moderate or vigorous exercise </a:t>
            </a:r>
            <a:r>
              <a:rPr lang="en-US" sz="3200" b="1" i="1" dirty="0">
                <a:latin typeface="Assistant" pitchFamily="2" charset="-79"/>
                <a:cs typeface="Assistant" pitchFamily="2" charset="-79"/>
              </a:rPr>
              <a:t>a week </a:t>
            </a:r>
            <a:r>
              <a:rPr lang="en-US" sz="3200" dirty="0">
                <a:latin typeface="Assistant" pitchFamily="2" charset="-79"/>
                <a:cs typeface="Assistant" pitchFamily="2" charset="-79"/>
              </a:rPr>
              <a:t>by our next session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ake your total active time over 250 min this week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Keep up your steps, reduce sedentary time– get all 9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Add volume and decrease calories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Keep the magic of fiber going throughout your day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Fill up on veggies before you start your meal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659923" y="8313008"/>
            <a:ext cx="1112287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MONTH’S TIP: </a:t>
            </a:r>
            <a:r>
              <a:rPr lang="en-US" sz="3200" b="1" i="1" u="sng" dirty="0">
                <a:solidFill>
                  <a:srgbClr val="FF0000"/>
                </a:solidFill>
              </a:rPr>
              <a:t>Overcoming Barriers</a:t>
            </a:r>
          </a:p>
          <a:p>
            <a:r>
              <a:rPr lang="en-US" sz="2800" dirty="0"/>
              <a:t>We can all do something healthy once, the trick is figuring out what gets in the way of making it our new routine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04095"/>
            <a:ext cx="16543470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or next month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ecrease your sedentary time! </a:t>
            </a:r>
          </a:p>
          <a:p>
            <a:pPr marL="514350" indent="-514350">
              <a:buFont typeface="+mj-lt"/>
              <a:buAutoNum type="arabicPeriod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rack your food and exercise and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Remember your calorie, fat, and activity targets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your logs and progress to the Intervention Team and Review the response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495800" y="8103233"/>
            <a:ext cx="12316505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r>
              <a:rPr lang="en-US" sz="3000" dirty="0"/>
              <a:t>Habits and routines are a great way to make sure you get your exercise. You’ll know the habit has really formed when you feel weird if you forget to do </a:t>
            </a:r>
            <a:r>
              <a:rPr lang="en-US" sz="3000"/>
              <a:t>it!</a:t>
            </a:r>
            <a:endParaRPr lang="en-US" sz="3000" dirty="0"/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649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LAST MONTH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every meal?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weigh every day, &amp; record your health today?</a:t>
            </a:r>
          </a:p>
          <a:p>
            <a:pPr marL="514350" indent="-514350">
              <a:buAutoNum type="arabicPeriod" startAt="2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Tx/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pump up the VOLUME on healthy filling food?</a:t>
            </a:r>
          </a:p>
          <a:p>
            <a:pPr marL="514350" indent="-514350">
              <a:buFontTx/>
              <a:buAutoNum type="arabicPeriod" startAt="2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mail the Intervention Team and review the respon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ealthy Lifestyle Tool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4EA457-461E-46A2-A093-04984227EE4D}"/>
              </a:ext>
            </a:extLst>
          </p:cNvPr>
          <p:cNvSpPr txBox="1"/>
          <p:nvPr/>
        </p:nvSpPr>
        <p:spPr>
          <a:xfrm>
            <a:off x="1450279" y="1870958"/>
            <a:ext cx="12125724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tools do you know about to support a healthy lifestyle?</a:t>
            </a: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(</a:t>
            </a:r>
            <a:r>
              <a:rPr lang="en-US" sz="3200" i="1" dirty="0">
                <a:latin typeface="Assistant" pitchFamily="2" charset="-79"/>
                <a:cs typeface="Assistant" pitchFamily="2" charset="-79"/>
              </a:rPr>
              <a:t>answer out loud or in the chat!)</a:t>
            </a: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3E5DA1E1-B2AD-44D5-862C-DDDDB6B89DD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rcRect l="193" r="1340"/>
          <a:stretch/>
        </p:blipFill>
        <p:spPr>
          <a:xfrm>
            <a:off x="9906001" y="5829300"/>
            <a:ext cx="7577412" cy="430548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DCCE5728-A68A-49B9-97B8-FF67E2B507E8}"/>
              </a:ext>
            </a:extLst>
          </p:cNvPr>
          <p:cNvSpPr txBox="1"/>
          <p:nvPr/>
        </p:nvSpPr>
        <p:spPr>
          <a:xfrm>
            <a:off x="1450279" y="3340613"/>
            <a:ext cx="12125724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tools have you tried that work for your lifestyle goals?</a:t>
            </a: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(</a:t>
            </a:r>
            <a:r>
              <a:rPr lang="en-US" sz="3200" i="1" dirty="0">
                <a:latin typeface="Assistant" pitchFamily="2" charset="-79"/>
                <a:cs typeface="Assistant" pitchFamily="2" charset="-79"/>
              </a:rPr>
              <a:t>answer out loud or in the chat!)</a:t>
            </a: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2856BAA-19EA-4700-A97C-1E9AF8F61820}"/>
              </a:ext>
            </a:extLst>
          </p:cNvPr>
          <p:cNvSpPr txBox="1"/>
          <p:nvPr/>
        </p:nvSpPr>
        <p:spPr>
          <a:xfrm>
            <a:off x="1450279" y="4886708"/>
            <a:ext cx="12125724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tools worked for you but you haven’t used in a while?</a:t>
            </a: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(</a:t>
            </a:r>
            <a:r>
              <a:rPr lang="en-US" sz="3200" i="1" dirty="0">
                <a:latin typeface="Assistant" pitchFamily="2" charset="-79"/>
                <a:cs typeface="Assistant" pitchFamily="2" charset="-79"/>
              </a:rPr>
              <a:t>answer out loud or in the chat!)</a:t>
            </a: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99984268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4" grpId="0"/>
      <p:bldP spid="25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1846659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Sitting Less Goals -- Open your Trackers</a:t>
            </a:r>
          </a:p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 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32" name="Picture 31" descr="Hands writing in notebook">
            <a:extLst>
              <a:ext uri="{FF2B5EF4-FFF2-40B4-BE49-F238E27FC236}">
                <a16:creationId xmlns:a16="http://schemas.microsoft.com/office/drawing/2014/main" id="{2FB8C4C5-4E57-4EBE-B2AA-D1309E4FA66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61" t="27778" r="8961" b="21852"/>
          <a:stretch/>
        </p:blipFill>
        <p:spPr>
          <a:xfrm>
            <a:off x="10456123" y="3113493"/>
            <a:ext cx="7105707" cy="2910771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E0D1254A-0382-4462-A097-834ED53D523F}"/>
              </a:ext>
            </a:extLst>
          </p:cNvPr>
          <p:cNvSpPr txBox="1"/>
          <p:nvPr/>
        </p:nvSpPr>
        <p:spPr>
          <a:xfrm>
            <a:off x="1507276" y="1774427"/>
            <a:ext cx="9296400" cy="8279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  <a:p>
            <a:r>
              <a:rPr lang="en-US" sz="3200" dirty="0"/>
              <a:t>What day of the week are you getting the most TAB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Monda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Tuesda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Wednesda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Thursda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Frida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Saturday 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Sunday</a:t>
            </a:r>
          </a:p>
          <a:p>
            <a:pPr marL="285750" indent="-285750">
              <a:buFontTx/>
              <a:buChar char="-"/>
            </a:pPr>
            <a:endParaRPr lang="en-US" dirty="0"/>
          </a:p>
          <a:p>
            <a:r>
              <a:rPr lang="en-US" sz="3200" dirty="0"/>
              <a:t>Is it the same for SUPER TABS?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Ye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No</a:t>
            </a:r>
          </a:p>
          <a:p>
            <a:pPr marL="285750" indent="-285750">
              <a:buFontTx/>
              <a:buChar char="-"/>
            </a:pPr>
            <a:endParaRPr lang="en-US" dirty="0"/>
          </a:p>
          <a:p>
            <a:r>
              <a:rPr lang="en-US" sz="3200" dirty="0"/>
              <a:t>What about time of day?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Morning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Afternoon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Evening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/>
              <a:t>Night</a:t>
            </a:r>
          </a:p>
          <a:p>
            <a:endParaRPr lang="en-US" dirty="0"/>
          </a:p>
        </p:txBody>
      </p:sp>
      <p:pic>
        <p:nvPicPr>
          <p:cNvPr id="35" name="Graphic 34" descr="Office Chair with solid fill">
            <a:extLst>
              <a:ext uri="{FF2B5EF4-FFF2-40B4-BE49-F238E27FC236}">
                <a16:creationId xmlns:a16="http://schemas.microsoft.com/office/drawing/2014/main" id="{0758D59B-CFF6-472D-8B20-B5D373F4BDA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0317320" y="6286500"/>
            <a:ext cx="1846658" cy="1846658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BB236D8F-8BE3-41EF-A940-000D0CA48CD2}"/>
              </a:ext>
            </a:extLst>
          </p:cNvPr>
          <p:cNvSpPr txBox="1"/>
          <p:nvPr/>
        </p:nvSpPr>
        <p:spPr>
          <a:xfrm>
            <a:off x="12192000" y="6286500"/>
            <a:ext cx="51816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Calculate your average daily TABS &amp; SUPER TABS and put it in the chat.</a:t>
            </a:r>
          </a:p>
          <a:p>
            <a:endParaRPr lang="en-US" sz="2400" dirty="0"/>
          </a:p>
          <a:p>
            <a:r>
              <a:rPr lang="en-US" sz="2400" dirty="0"/>
              <a:t>How do you compare to other group members?</a:t>
            </a:r>
          </a:p>
        </p:txBody>
      </p:sp>
    </p:spTree>
    <p:extLst>
      <p:ext uri="{BB962C8B-B14F-4D97-AF65-F5344CB8AC3E}">
        <p14:creationId xmlns:p14="http://schemas.microsoft.com/office/powerpoint/2010/main" val="35425135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Make your TABS Boost Your Goal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447891" y="2705190"/>
            <a:ext cx="8325394" cy="50783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1"/>
            <a:r>
              <a:rPr lang="en-US" sz="3600" dirty="0">
                <a:latin typeface="Assistant Regular" charset="-79"/>
                <a:cs typeface="Assistant Regular" charset="-79"/>
              </a:rPr>
              <a:t>Use TABS as an excuse to get your active zone minutes and </a:t>
            </a:r>
            <a:r>
              <a:rPr lang="en-US" sz="3600" b="1" u="sng" dirty="0">
                <a:latin typeface="Assistant Regular" charset="-79"/>
                <a:cs typeface="Assistant Regular" charset="-79"/>
              </a:rPr>
              <a:t>go 2 for 1!</a:t>
            </a:r>
          </a:p>
          <a:p>
            <a:pPr lvl="1"/>
            <a:endParaRPr lang="en-US" sz="3600" dirty="0">
              <a:latin typeface="Assistant Regular" charset="-79"/>
              <a:cs typeface="Assistant Regular" charset="-79"/>
            </a:endParaRPr>
          </a:p>
          <a:p>
            <a:pPr lvl="1"/>
            <a:r>
              <a:rPr lang="en-US" sz="3600" dirty="0">
                <a:latin typeface="Assistant Regular" charset="-79"/>
                <a:cs typeface="Assistant Regular" charset="-79"/>
              </a:rPr>
              <a:t>Plan out your TABS like your plan your physical activity. (page 3)</a:t>
            </a:r>
          </a:p>
          <a:p>
            <a:pPr lvl="1"/>
            <a:endParaRPr lang="en-US" sz="3600" dirty="0">
              <a:latin typeface="Assistant Regular" charset="-79"/>
              <a:cs typeface="Assistant Regular" charset="-79"/>
            </a:endParaRPr>
          </a:p>
          <a:p>
            <a:pPr lvl="1"/>
            <a:r>
              <a:rPr lang="en-US" sz="3600" dirty="0">
                <a:latin typeface="Assistant Regular" charset="-79"/>
                <a:cs typeface="Assistant Regular" charset="-79"/>
              </a:rPr>
              <a:t>When can you sneak in an extra 10 minutes of standing, walking, or jogging in place? (</a:t>
            </a:r>
            <a:r>
              <a:rPr lang="en-US" sz="3600" i="1" dirty="0">
                <a:latin typeface="Assistant Regular" charset="-79"/>
                <a:cs typeface="Assistant Regular" charset="-79"/>
              </a:rPr>
              <a:t>discuss)</a:t>
            </a:r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2052" name="Picture 4">
            <a:extLst>
              <a:ext uri="{FF2B5EF4-FFF2-40B4-BE49-F238E27FC236}">
                <a16:creationId xmlns:a16="http://schemas.microsoft.com/office/drawing/2014/main" id="{C2C065A0-B91D-47E4-91D9-B0B8F7C5A77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rcRect l="8907"/>
          <a:stretch/>
        </p:blipFill>
        <p:spPr bwMode="auto">
          <a:xfrm>
            <a:off x="10566570" y="2906047"/>
            <a:ext cx="7098971" cy="46765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503772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osture for Health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rcRect l="12537" t="-4211" r="6336" b="4211"/>
          <a:stretch/>
        </p:blipFill>
        <p:spPr bwMode="auto">
          <a:xfrm>
            <a:off x="9601287" y="4152900"/>
            <a:ext cx="8382000" cy="5719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555197" y="2054616"/>
            <a:ext cx="10698718" cy="48936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How is your posture, typically?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’m always on top of good posture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try to remember to sit and stand up straight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ometimes good, sometimes bad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ften have bad posture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never have good posture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0900642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Top Reasons for Good Postur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rcRect t="17046" b="17046"/>
          <a:stretch/>
        </p:blipFill>
        <p:spPr bwMode="auto">
          <a:xfrm>
            <a:off x="12312434" y="2022465"/>
            <a:ext cx="5377056" cy="53549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555197" y="2054616"/>
            <a:ext cx="10698718" cy="61863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Works core muscles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Reduces back and neck pain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Makes exercise easier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Works muscles evenly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Limits breathing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Impacts blood pressure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Improves appearance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C69B399-1AB3-49E0-B0DE-847D9607AF87}"/>
              </a:ext>
            </a:extLst>
          </p:cNvPr>
          <p:cNvSpPr txBox="1"/>
          <p:nvPr/>
        </p:nvSpPr>
        <p:spPr>
          <a:xfrm>
            <a:off x="12253915" y="7734300"/>
            <a:ext cx="534828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My neck hurts just looking at this.</a:t>
            </a:r>
          </a:p>
          <a:p>
            <a:endParaRPr lang="en-US" sz="2400" dirty="0"/>
          </a:p>
          <a:p>
            <a:r>
              <a:rPr lang="en-US" sz="2400" dirty="0"/>
              <a:t>What is your problem posture activity?</a:t>
            </a:r>
          </a:p>
        </p:txBody>
      </p:sp>
    </p:spTree>
    <p:extLst>
      <p:ext uri="{BB962C8B-B14F-4D97-AF65-F5344CB8AC3E}">
        <p14:creationId xmlns:p14="http://schemas.microsoft.com/office/powerpoint/2010/main" val="14062464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y do I want to stay active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 descr="Woman balancing on kettlebells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53" r="16953"/>
          <a:stretch/>
        </p:blipFill>
        <p:spPr bwMode="auto">
          <a:xfrm>
            <a:off x="12317027" y="2721519"/>
            <a:ext cx="5743139" cy="5719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555197" y="2054616"/>
            <a:ext cx="10698718" cy="68634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What is your activity motivation?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I feel better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I’m looking better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Gives me something to do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A good way to spend time with friends and family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Live longer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Helps control weight and health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6" name="Graphic 5" descr="Boot with solid fill">
            <a:extLst>
              <a:ext uri="{FF2B5EF4-FFF2-40B4-BE49-F238E27FC236}">
                <a16:creationId xmlns:a16="http://schemas.microsoft.com/office/drawing/2014/main" id="{47BAE73D-8873-45AB-8ABE-EE6F488D878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/>
          <a:stretch/>
        </p:blipFill>
        <p:spPr>
          <a:xfrm>
            <a:off x="12392392" y="8753491"/>
            <a:ext cx="970939" cy="97093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DB02A1C-00F6-4749-90D0-092513840EB3}"/>
              </a:ext>
            </a:extLst>
          </p:cNvPr>
          <p:cNvSpPr txBox="1"/>
          <p:nvPr/>
        </p:nvSpPr>
        <p:spPr>
          <a:xfrm>
            <a:off x="13492520" y="8753491"/>
            <a:ext cx="456764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What is your favorite way to get in your active zone minutes?</a:t>
            </a:r>
          </a:p>
        </p:txBody>
      </p:sp>
    </p:spTree>
    <p:extLst>
      <p:ext uri="{BB962C8B-B14F-4D97-AF65-F5344CB8AC3E}">
        <p14:creationId xmlns:p14="http://schemas.microsoft.com/office/powerpoint/2010/main" val="33468702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Barriers and Coping Strategie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rcRect l="21759" r="21759"/>
          <a:stretch/>
        </p:blipFill>
        <p:spPr bwMode="auto">
          <a:xfrm>
            <a:off x="12190803" y="2682989"/>
            <a:ext cx="5743139" cy="5719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492085" y="2044309"/>
            <a:ext cx="10698718" cy="83407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What gets in the way of moving for you?</a:t>
            </a:r>
          </a:p>
          <a:p>
            <a:endParaRPr lang="en-US" sz="44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What are some ways you have overcome those barriers?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Made a physical activity plan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Set up an accountability friend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Read Fitbit notifications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Check in with Intervention Team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Turned off the TV and gotten moving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Other- discuss?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2431855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83</TotalTime>
  <Words>823</Words>
  <Application>Microsoft Office PowerPoint</Application>
  <PresentationFormat>Custom</PresentationFormat>
  <Paragraphs>191</Paragraphs>
  <Slides>13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3" baseType="lpstr">
      <vt:lpstr>Courier New</vt:lpstr>
      <vt:lpstr>Assistant Regular</vt:lpstr>
      <vt:lpstr>Assistant Bold</vt:lpstr>
      <vt:lpstr>Assistant ExtraBold</vt:lpstr>
      <vt:lpstr>Calibri</vt:lpstr>
      <vt:lpstr>Wingdings</vt:lpstr>
      <vt:lpstr>Arial</vt:lpstr>
      <vt:lpstr>Assistant</vt:lpstr>
      <vt:lpstr>Assistant SemiBol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423</cp:revision>
  <dcterms:created xsi:type="dcterms:W3CDTF">2006-08-16T00:00:00Z</dcterms:created>
  <dcterms:modified xsi:type="dcterms:W3CDTF">2023-11-03T21:17:56Z</dcterms:modified>
  <dc:identifier>DAE7nbwep5o</dc:identifier>
</cp:coreProperties>
</file>